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8273D-12AA-43CB-93F1-8DF56193DD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D1E1E4-67B7-4649-8204-D79B09DE2E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C85EB-D5F6-44CB-ACDF-5115D1245D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0E673-9B07-4A82-8369-5ADB31DF5F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BF820-16CC-47BD-8304-8A944E6B62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04391-B53C-4F9A-B19E-26FE500F31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B6BEF-1479-428A-938E-51B60F7FCD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6420C-0A68-4C7A-B7A3-E31A8F62CF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558840-7760-402B-A2D4-26B9266140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398D3-C063-4234-A491-7D71108C10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BF097A-8A8D-439B-8167-1378EFF117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6E6C8-6398-4911-B9E2-83C4BBC415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28CCD6-EB3F-4EF0-8340-276D2A19151D}" type="slidenum">
              <a:rPr b="0" lang="nl-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4"/>
          <p:cNvGraphicFramePr/>
          <p:nvPr/>
        </p:nvGraphicFramePr>
        <p:xfrm>
          <a:off x="250920" y="333360"/>
          <a:ext cx="6068880" cy="2898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0920" y="333360"/>
                    <a:ext cx="6068880" cy="2898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Rectangle 1"/>
          <p:cNvSpPr/>
          <p:nvPr/>
        </p:nvSpPr>
        <p:spPr>
          <a:xfrm>
            <a:off x="250920" y="3573360"/>
            <a:ext cx="6481800" cy="207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Additional Figure 4. Differential leukocyte analysis in mCRPC patients before and during prostate GVAX/ipilimumab therapy. 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Absolute lymphocytes (white squares) and monocyte </a:t>
            </a:r>
            <a:r>
              <a:rPr b="0" lang="nl-NL" sz="1300" spc="-1" strike="noStrike">
                <a:solidFill>
                  <a:srgbClr val="000000"/>
                </a:solidFill>
                <a:latin typeface="Arial"/>
              </a:rPr>
              <a:t>(black squares) counts were determined b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efore (week 0/visit 1 (w0v1)), during (w4v3, w8v5, w16v9) and after (follow-up (fu)) prostate GVAX/ipilimumab therapy. Mean absolute counts 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± SEM 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is given in 10</a:t>
            </a:r>
            <a:r>
              <a:rPr b="0" lang="en-US" sz="1300" spc="-1" strike="noStrike" baseline="30000">
                <a:solidFill>
                  <a:srgbClr val="000000"/>
                </a:solidFill>
                <a:latin typeface="Arial"/>
              </a:rPr>
              <a:t>e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6 per ml of blood for lymphocytes (white squares), monocytes </a:t>
            </a:r>
            <a:r>
              <a:rPr b="0" lang="nl-NL" sz="1300" spc="-1" strike="noStrike">
                <a:solidFill>
                  <a:srgbClr val="000000"/>
                </a:solidFill>
                <a:latin typeface="Arial"/>
              </a:rPr>
              <a:t>(black squares) and the sum of lymphocytes and monocytes (i.e. PBMC, grey squares).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Differences between pre- and on- or post-treatment were analyzed with the repeated measures ANOVA with a post-hoc Dunnett’s multiple comparisons test. Differences were considered significant when p&lt;0.05, as indicated with an asterisk (* p&lt;0.05, ** p&lt;0.01).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kstvak 110"/>
          <p:cNvSpPr/>
          <p:nvPr/>
        </p:nvSpPr>
        <p:spPr>
          <a:xfrm>
            <a:off x="7691400" y="0"/>
            <a:ext cx="145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dditional Figure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4T08:52:33Z</dcterms:created>
  <dc:creator>admin-iod</dc:creator>
  <dc:description/>
  <dc:language>en-US</dc:language>
  <cp:lastModifiedBy>Santegoets, S.J.A.M. (ONCO)</cp:lastModifiedBy>
  <dcterms:modified xsi:type="dcterms:W3CDTF">2014-06-30T07:00:25Z</dcterms:modified>
  <cp:revision>636</cp:revision>
  <dc:subject/>
  <dc:title>Slide 1</dc:title>
</cp:coreProperties>
</file>